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AED5E1-C586-4820-8A44-210471BB897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796DD3-A6DA-4A6B-AA9A-012630E79E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A3F91A-12D0-441B-9525-4387FAE05BF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CBBC2-2C47-44F6-8F3B-CF76949683B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848353-33C7-4F2D-BCC7-C1B97DAC55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46F912-F5AF-4E9E-9840-16D1512725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15319A-1074-45C6-AF90-3CC8887CCE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945329-AE2E-42D0-BE23-FB7CEFC21A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4FC1E7-4EA2-49D1-B712-39B14CE88F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4859B8-8485-450F-B32D-AC7BC23B69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368BAA-8AAE-436A-B022-BED24F2F61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5F76F6-4BD2-4E9F-9A76-108D2B073F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256500-3D2E-4440-A953-D254B0EC78B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88360" y="786600"/>
            <a:ext cx="151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宋体"/>
              </a:rPr>
              <a:t>JAK/STAT pathway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: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549520" y="787320"/>
            <a:ext cx="182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宋体"/>
              </a:rPr>
              <a:t>PI3K- activation pathw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rot="16200000">
            <a:off x="-997560" y="4029120"/>
            <a:ext cx="251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TAT5        STAT4            STA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52280" y="2743200"/>
            <a:ext cx="0" cy="2590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6200000">
            <a:off x="-505080" y="3984840"/>
            <a:ext cx="1130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arget gen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52280" y="457200"/>
            <a:ext cx="885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   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(A)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           (B)                                (C)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	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" descr=""/>
          <p:cNvPicPr/>
          <p:nvPr/>
        </p:nvPicPr>
        <p:blipFill>
          <a:blip r:embed="rId1"/>
          <a:srcRect l="0" t="0" r="15491" b="6623"/>
          <a:stretch/>
        </p:blipFill>
        <p:spPr>
          <a:xfrm>
            <a:off x="307800" y="1193760"/>
            <a:ext cx="2286000" cy="411480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7088400" y="786600"/>
            <a:ext cx="156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5748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宋体"/>
              </a:rPr>
              <a:t>II) NF-</a:t>
            </a:r>
            <a:r>
              <a:rPr b="0" lang="el-GR" sz="1200" spc="-1" strike="noStrike" u="sng">
                <a:solidFill>
                  <a:srgbClr val="000000"/>
                </a:solidFill>
                <a:uFillTx/>
                <a:latin typeface="Univers"/>
                <a:ea typeface="宋体"/>
              </a:rPr>
              <a:t>κ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宋体"/>
              </a:rPr>
              <a:t>B target 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617720" y="786600"/>
            <a:ext cx="195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宋体"/>
              </a:rPr>
              <a:t>I) NF-κB pathway regul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2"/>
          <a:srcRect l="0" t="0" r="5368" b="3845"/>
          <a:stretch/>
        </p:blipFill>
        <p:spPr>
          <a:xfrm>
            <a:off x="4675320" y="1168560"/>
            <a:ext cx="4478040" cy="307332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3"/>
          <a:stretch/>
        </p:blipFill>
        <p:spPr>
          <a:xfrm>
            <a:off x="3475080" y="3565440"/>
            <a:ext cx="2486160" cy="55872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2965680" y="4079880"/>
            <a:ext cx="38930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olds of expression compared with lymphoid standard in log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2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ca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" descr=""/>
          <p:cNvPicPr/>
          <p:nvPr/>
        </p:nvPicPr>
        <p:blipFill>
          <a:blip r:embed="rId4"/>
          <a:srcRect l="0" t="3386" r="0" b="2842"/>
          <a:stretch/>
        </p:blipFill>
        <p:spPr>
          <a:xfrm>
            <a:off x="2624040" y="1228680"/>
            <a:ext cx="2057400" cy="1809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9-04T02:38:06Z</dcterms:created>
  <dc:creator>jiqbal</dc:creator>
  <dc:description/>
  <dc:language>en-US</dc:language>
  <cp:lastModifiedBy>jiqbal</cp:lastModifiedBy>
  <dcterms:modified xsi:type="dcterms:W3CDTF">2007-07-06T01:51:36Z</dcterms:modified>
  <cp:revision>30</cp:revision>
  <dc:subject/>
  <dc:title>Slide 1</dc:title>
</cp:coreProperties>
</file>